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8" r:id="rId3"/>
    <p:sldId id="257" r:id="rId4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9" d="100"/>
          <a:sy n="89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18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369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216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661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82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139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526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71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703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3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635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007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426822-0DEE-2F46-BF8C-FDF7DB4B1E26}" type="datetimeFigureOut">
              <a:rPr lang="en-US" smtClean="0"/>
              <a:t>2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861DBA-9056-C641-A6FA-7F9F65517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476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BD98D11-5A4F-5169-7F41-71786C1BAE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728" y="441948"/>
            <a:ext cx="6691744" cy="645891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133D606-D5E2-1F95-E372-AB73A940E270}"/>
              </a:ext>
            </a:extLst>
          </p:cNvPr>
          <p:cNvSpPr txBox="1"/>
          <p:nvPr/>
        </p:nvSpPr>
        <p:spPr>
          <a:xfrm>
            <a:off x="92127" y="7158038"/>
            <a:ext cx="713094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1</a:t>
            </a:r>
            <a:r>
              <a:rPr lang="en-US" sz="2000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2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ene transcription of </a:t>
            </a:r>
            <a:r>
              <a:rPr lang="en-US" sz="2000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dkn2a </a:t>
            </a:r>
            <a:r>
              <a:rPr lang="en-US" sz="2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i.e., p16) in the skeletal muscle of young and old vehicle-treated mice and old fisetin-treated mice. *p&lt;0.05 &amp; **p&lt;0.01 shown as Log</a:t>
            </a:r>
            <a:r>
              <a:rPr lang="en-US" sz="2000" baseline="-25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US" sz="2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fold change. Ordinary one-way ANOVA with Tukey’s multiple comparisons test.</a:t>
            </a:r>
          </a:p>
          <a:p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496282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3E6C3CD-7A44-1C83-BD98-FF07119284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B7C304A-0E40-20E9-7F5C-D53C162D1EDB}"/>
              </a:ext>
            </a:extLst>
          </p:cNvPr>
          <p:cNvSpPr txBox="1"/>
          <p:nvPr/>
        </p:nvSpPr>
        <p:spPr>
          <a:xfrm>
            <a:off x="92127" y="7158038"/>
            <a:ext cx="713094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2000" b="1" i="1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US" b="1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2</a:t>
            </a:r>
            <a:r>
              <a:rPr lang="en-US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ifferentially expressed genes (DEGs) depicted via volcano plot (Log2FoldChange &gt; ± 0.5 and p&lt;0.05) (</a:t>
            </a:r>
            <a:r>
              <a:rPr lang="en-US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2A</a:t>
            </a:r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and enriched KEGG pathways (false discovery rate [FDR] &lt; 0.2) (</a:t>
            </a:r>
            <a:r>
              <a:rPr lang="en-US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2B</a:t>
            </a:r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identified in old mice following fisetin treatment compared to old vehicle-treated mice. Venn diagram analysis of DEGs across comparison groups (</a:t>
            </a:r>
            <a:r>
              <a:rPr lang="en-US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2C</a:t>
            </a:r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. 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CFF4A42-BD86-4653-BFA1-AB69B1FF6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9109" y="40104"/>
            <a:ext cx="3765854" cy="7464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681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1EC01F-DBE2-377E-59EF-C3B71EAFA9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939AA50-9859-8B34-E4E7-6008719F6F01}"/>
              </a:ext>
            </a:extLst>
          </p:cNvPr>
          <p:cNvSpPr txBox="1"/>
          <p:nvPr/>
        </p:nvSpPr>
        <p:spPr>
          <a:xfrm>
            <a:off x="92127" y="6524104"/>
            <a:ext cx="7130946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3</a:t>
            </a:r>
            <a:r>
              <a:rPr lang="en-US" sz="2000" i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2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keletal muscle gene expression of cellular senescence markers in young and old vehicle-treated mice, old ganciclovir (GCV)-treated mice, and old ABT-263-treated mice as assessed by reverse transcription polymerase chain reaction. </a:t>
            </a:r>
            <a:r>
              <a:rPr lang="en-US" sz="1800" i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dkn1a 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p21; </a:t>
            </a:r>
            <a:r>
              <a:rPr lang="en-US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3A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; </a:t>
            </a:r>
            <a:r>
              <a:rPr lang="en-US" sz="1800" i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dkn2a 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p16; </a:t>
            </a:r>
            <a:r>
              <a:rPr lang="en-US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3B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; </a:t>
            </a:r>
            <a:r>
              <a:rPr lang="en-US" sz="1800" i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AI1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plasminogen activator inhibitor-1; </a:t>
            </a:r>
            <a:r>
              <a:rPr lang="en-US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3C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; and </a:t>
            </a:r>
            <a:r>
              <a:rPr lang="en-US" sz="1800" i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MNB1 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Lamin B1; </a:t>
            </a:r>
            <a:r>
              <a:rPr lang="en-US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3D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. *p&lt;0.05 compared with young vehicle-treated mice; </a:t>
            </a:r>
            <a:r>
              <a:rPr lang="en-US" sz="1800" baseline="300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‡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&lt;0.05 compared with old ABT-263-treated mice; </a:t>
            </a:r>
            <a:r>
              <a:rPr lang="en-US" sz="1800" baseline="300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#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&lt;0.05 compared with old GCV-treated mice. Ordinary one-way ANOVA with Tukey’s multiple comparisons test.</a:t>
            </a:r>
            <a:r>
              <a:rPr lang="en-US" sz="2000" dirty="0">
                <a:effectLst/>
              </a:rPr>
              <a:t> </a:t>
            </a:r>
            <a:endParaRPr lang="en-US" sz="20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70FADF-E67C-88D3-B368-8766B2C225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-57153"/>
            <a:ext cx="7586431" cy="65749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4689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29</Words>
  <Application>Microsoft Macintosh PowerPoint</Application>
  <PresentationFormat>Custom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urray,Kevin O</dc:creator>
  <cp:lastModifiedBy>Kevin Murray</cp:lastModifiedBy>
  <cp:revision>5</cp:revision>
  <dcterms:created xsi:type="dcterms:W3CDTF">2025-01-05T03:52:24Z</dcterms:created>
  <dcterms:modified xsi:type="dcterms:W3CDTF">2025-02-12T20:20:34Z</dcterms:modified>
</cp:coreProperties>
</file>